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318" r:id="rId5"/>
    <p:sldId id="313" r:id="rId6"/>
    <p:sldId id="314" r:id="rId7"/>
    <p:sldId id="315" r:id="rId8"/>
    <p:sldId id="316" r:id="rId9"/>
    <p:sldId id="317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7A895C-A111-4B36-9B94-EF30860F6534}" v="1" dt="2026-01-30T22:07:09.40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3534" y="17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yzlak, Brian M" userId="S::bgryzlak@uiowa.edu::8f414da2-3e77-41fd-98cb-53487c721f01" providerId="AD" clId="Web-{AC153F01-5F8C-A358-B739-3EC0AC92A9BE}"/>
    <pc:docChg chg="modSld">
      <pc:chgData name="Gryzlak, Brian M" userId="S::bgryzlak@uiowa.edu::8f414da2-3e77-41fd-98cb-53487c721f01" providerId="AD" clId="Web-{AC153F01-5F8C-A358-B739-3EC0AC92A9BE}" dt="2025-05-15T01:19:48.538" v="11" actId="20577"/>
      <pc:docMkLst>
        <pc:docMk/>
      </pc:docMkLst>
      <pc:sldChg chg="modSp">
        <pc:chgData name="Gryzlak, Brian M" userId="S::bgryzlak@uiowa.edu::8f414da2-3e77-41fd-98cb-53487c721f01" providerId="AD" clId="Web-{AC153F01-5F8C-A358-B739-3EC0AC92A9BE}" dt="2025-05-15T01:19:48.538" v="11" actId="20577"/>
        <pc:sldMkLst>
          <pc:docMk/>
          <pc:sldMk cId="655086606" sldId="314"/>
        </pc:sldMkLst>
      </pc:sldChg>
    </pc:docChg>
  </pc:docChgLst>
  <pc:docChgLst>
    <pc:chgData name="O'Rorke, Michael A" userId="ae080fd6-c620-4127-bd2c-84f1dacc7cb3" providerId="ADAL" clId="{8C7A895C-A111-4B36-9B94-EF30860F6534}"/>
    <pc:docChg chg="custSel addSld modSld">
      <pc:chgData name="O'Rorke, Michael A" userId="ae080fd6-c620-4127-bd2c-84f1dacc7cb3" providerId="ADAL" clId="{8C7A895C-A111-4B36-9B94-EF30860F6534}" dt="2026-01-30T22:08:25.225" v="33" actId="1076"/>
      <pc:docMkLst>
        <pc:docMk/>
      </pc:docMkLst>
      <pc:sldChg chg="addSp delSp modSp new mod">
        <pc:chgData name="O'Rorke, Michael A" userId="ae080fd6-c620-4127-bd2c-84f1dacc7cb3" providerId="ADAL" clId="{8C7A895C-A111-4B36-9B94-EF30860F6534}" dt="2026-01-30T22:08:25.225" v="33" actId="1076"/>
        <pc:sldMkLst>
          <pc:docMk/>
          <pc:sldMk cId="1179654805" sldId="318"/>
        </pc:sldMkLst>
        <pc:spChg chg="del">
          <ac:chgData name="O'Rorke, Michael A" userId="ae080fd6-c620-4127-bd2c-84f1dacc7cb3" providerId="ADAL" clId="{8C7A895C-A111-4B36-9B94-EF30860F6534}" dt="2026-01-30T22:07:06.314" v="1" actId="478"/>
          <ac:spMkLst>
            <pc:docMk/>
            <pc:sldMk cId="1179654805" sldId="318"/>
            <ac:spMk id="2" creationId="{4FDC73CF-84C7-C6C7-F552-D6E98DF1993D}"/>
          </ac:spMkLst>
        </pc:spChg>
        <pc:spChg chg="del">
          <ac:chgData name="O'Rorke, Michael A" userId="ae080fd6-c620-4127-bd2c-84f1dacc7cb3" providerId="ADAL" clId="{8C7A895C-A111-4B36-9B94-EF30860F6534}" dt="2026-01-30T22:07:07.263" v="2" actId="478"/>
          <ac:spMkLst>
            <pc:docMk/>
            <pc:sldMk cId="1179654805" sldId="318"/>
            <ac:spMk id="3" creationId="{26695C86-DD31-62CC-C525-A823F05313B5}"/>
          </ac:spMkLst>
        </pc:spChg>
        <pc:spChg chg="add mod">
          <ac:chgData name="O'Rorke, Michael A" userId="ae080fd6-c620-4127-bd2c-84f1dacc7cb3" providerId="ADAL" clId="{8C7A895C-A111-4B36-9B94-EF30860F6534}" dt="2026-01-30T22:08:14.848" v="29" actId="1076"/>
          <ac:spMkLst>
            <pc:docMk/>
            <pc:sldMk cId="1179654805" sldId="318"/>
            <ac:spMk id="6" creationId="{B5FB0448-CC80-BA36-F404-0157BA471845}"/>
          </ac:spMkLst>
        </pc:spChg>
        <pc:picChg chg="add mod">
          <ac:chgData name="O'Rorke, Michael A" userId="ae080fd6-c620-4127-bd2c-84f1dacc7cb3" providerId="ADAL" clId="{8C7A895C-A111-4B36-9B94-EF30860F6534}" dt="2026-01-30T22:08:25.225" v="33" actId="1076"/>
          <ac:picMkLst>
            <pc:docMk/>
            <pc:sldMk cId="1179654805" sldId="318"/>
            <ac:picMk id="4" creationId="{DB2E2D69-6EB3-41AA-0A67-944498E453D8}"/>
          </ac:picMkLst>
        </pc:picChg>
      </pc:sldChg>
    </pc:docChg>
  </pc:docChgLst>
  <pc:docChgLst>
    <pc:chgData name="Gryzlak, Brian M" userId="S::bgryzlak@uiowa.edu::8f414da2-3e77-41fd-98cb-53487c721f01" providerId="AD" clId="Web-{9E165FC8-6BE0-4C81-3E6D-C0C3A739D199}"/>
    <pc:docChg chg="addSld delSld">
      <pc:chgData name="Gryzlak, Brian M" userId="S::bgryzlak@uiowa.edu::8f414da2-3e77-41fd-98cb-53487c721f01" providerId="AD" clId="Web-{9E165FC8-6BE0-4C81-3E6D-C0C3A739D199}" dt="2025-05-15T01:22:33.783" v="1"/>
      <pc:docMkLst>
        <pc:docMk/>
      </pc:docMkLst>
      <pc:sldChg chg="add del replId">
        <pc:chgData name="Gryzlak, Brian M" userId="S::bgryzlak@uiowa.edu::8f414da2-3e77-41fd-98cb-53487c721f01" providerId="AD" clId="Web-{9E165FC8-6BE0-4C81-3E6D-C0C3A739D199}" dt="2025-05-15T01:22:33.783" v="1"/>
        <pc:sldMkLst>
          <pc:docMk/>
          <pc:sldMk cId="4173463974" sldId="318"/>
        </pc:sldMkLst>
      </pc:sldChg>
    </pc:docChg>
  </pc:docChgLst>
  <pc:docChgLst>
    <pc:chgData name="Gryzlak, Brian M" userId="8f414da2-3e77-41fd-98cb-53487c721f01" providerId="ADAL" clId="{96866918-38BA-4827-8526-E35B6D61648A}"/>
    <pc:docChg chg="undo custSel addSld modSld">
      <pc:chgData name="Gryzlak, Brian M" userId="8f414da2-3e77-41fd-98cb-53487c721f01" providerId="ADAL" clId="{96866918-38BA-4827-8526-E35B6D61648A}" dt="2025-05-08T15:19:53.432" v="2481" actId="313"/>
      <pc:docMkLst>
        <pc:docMk/>
      </pc:docMkLst>
      <pc:sldChg chg="modSp add mod">
        <pc:chgData name="Gryzlak, Brian M" userId="8f414da2-3e77-41fd-98cb-53487c721f01" providerId="ADAL" clId="{96866918-38BA-4827-8526-E35B6D61648A}" dt="2025-05-08T14:02:58.781" v="54" actId="20577"/>
        <pc:sldMkLst>
          <pc:docMk/>
          <pc:sldMk cId="4035139533" sldId="313"/>
        </pc:sldMkLst>
      </pc:sldChg>
      <pc:sldChg chg="addSp delSp modSp add mod">
        <pc:chgData name="Gryzlak, Brian M" userId="8f414da2-3e77-41fd-98cb-53487c721f01" providerId="ADAL" clId="{96866918-38BA-4827-8526-E35B6D61648A}" dt="2025-05-08T14:08:28.853" v="58" actId="478"/>
        <pc:sldMkLst>
          <pc:docMk/>
          <pc:sldMk cId="655086606" sldId="314"/>
        </pc:sldMkLst>
      </pc:sldChg>
      <pc:sldChg chg="addSp delSp modSp new mod chgLayout">
        <pc:chgData name="Gryzlak, Brian M" userId="8f414da2-3e77-41fd-98cb-53487c721f01" providerId="ADAL" clId="{96866918-38BA-4827-8526-E35B6D61648A}" dt="2025-05-08T15:07:28.114" v="1578" actId="20577"/>
        <pc:sldMkLst>
          <pc:docMk/>
          <pc:sldMk cId="719997376" sldId="315"/>
        </pc:sldMkLst>
      </pc:sldChg>
      <pc:sldChg chg="addSp delSp modSp add mod">
        <pc:chgData name="Gryzlak, Brian M" userId="8f414da2-3e77-41fd-98cb-53487c721f01" providerId="ADAL" clId="{96866918-38BA-4827-8526-E35B6D61648A}" dt="2025-05-08T15:06:31.834" v="1551" actId="12788"/>
        <pc:sldMkLst>
          <pc:docMk/>
          <pc:sldMk cId="1660527133" sldId="316"/>
        </pc:sldMkLst>
      </pc:sldChg>
      <pc:sldChg chg="addSp delSp modSp add mod chgLayout">
        <pc:chgData name="Gryzlak, Brian M" userId="8f414da2-3e77-41fd-98cb-53487c721f01" providerId="ADAL" clId="{96866918-38BA-4827-8526-E35B6D61648A}" dt="2025-05-08T15:19:53.432" v="2481" actId="313"/>
        <pc:sldMkLst>
          <pc:docMk/>
          <pc:sldMk cId="4033951753" sldId="317"/>
        </pc:sldMkLst>
      </pc:sldChg>
    </pc:docChg>
  </pc:docChgLst>
  <pc:docChgLst>
    <pc:chgData name="Gryzlak, Brian M" userId="8f414da2-3e77-41fd-98cb-53487c721f01" providerId="ADAL" clId="{7E05581D-F094-44D6-82E4-0DA5461BCBAB}"/>
    <pc:docChg chg="custSel modSld">
      <pc:chgData name="Gryzlak, Brian M" userId="8f414da2-3e77-41fd-98cb-53487c721f01" providerId="ADAL" clId="{7E05581D-F094-44D6-82E4-0DA5461BCBAB}" dt="2025-05-15T01:25:33.114" v="10" actId="20577"/>
      <pc:docMkLst>
        <pc:docMk/>
      </pc:docMkLst>
      <pc:sldChg chg="modSp mod">
        <pc:chgData name="Gryzlak, Brian M" userId="8f414da2-3e77-41fd-98cb-53487c721f01" providerId="ADAL" clId="{7E05581D-F094-44D6-82E4-0DA5461BCBAB}" dt="2025-05-15T01:25:16.103" v="9" actId="6549"/>
        <pc:sldMkLst>
          <pc:docMk/>
          <pc:sldMk cId="655086606" sldId="314"/>
        </pc:sldMkLst>
      </pc:sldChg>
      <pc:sldChg chg="delSp mod">
        <pc:chgData name="Gryzlak, Brian M" userId="8f414da2-3e77-41fd-98cb-53487c721f01" providerId="ADAL" clId="{7E05581D-F094-44D6-82E4-0DA5461BCBAB}" dt="2025-05-15T01:24:51.975" v="1" actId="478"/>
        <pc:sldMkLst>
          <pc:docMk/>
          <pc:sldMk cId="1660527133" sldId="316"/>
        </pc:sldMkLst>
      </pc:sldChg>
      <pc:sldChg chg="modSp mod">
        <pc:chgData name="Gryzlak, Brian M" userId="8f414da2-3e77-41fd-98cb-53487c721f01" providerId="ADAL" clId="{7E05581D-F094-44D6-82E4-0DA5461BCBAB}" dt="2025-05-15T01:25:33.114" v="10" actId="20577"/>
        <pc:sldMkLst>
          <pc:docMk/>
          <pc:sldMk cId="4033951753" sldId="31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5CDB3B-FEFB-4499-8F05-65124D7D6038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8F078C-C71C-4FD1-A649-99924FDC20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523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0C3AB9-0EB7-4D0A-9490-3057A1CDE31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3560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C0C3AB9-0EB7-4D0A-9490-3057A1CDE31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9508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FF995-8307-9AFC-8699-034089632C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27DC854-1BA8-B138-6A76-D10A30C578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B04AC1-BEF3-3FC6-9C0F-ED8C33552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B54680-7652-7F97-A0C8-F955365EF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531097-5BBD-3CCA-96DC-0B145042A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133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17104A-2E98-8AD3-A013-3A1E27882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499B24-193E-2B8D-A728-FB23AB6AB4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45CE41-C09E-F4EB-6A96-E2E48A6E1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6F97B2-86F8-284A-B7E6-17E39252D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FA78F-2531-146C-DCF7-46221EF2B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66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694B08-E4B8-ABF0-97A4-50517E36F1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E1E23F-28D3-24A6-20B9-6F1B413EB3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7F288-9563-6548-107B-444EEDDAE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E4EDB-5C13-29CC-A62B-F03B49AFE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573CEA-D01E-AA93-C283-56338AF3D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84491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FA786382-8FB2-9842-8E49-91C2AEDE13B7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701749" y="1965963"/>
            <a:ext cx="11047228" cy="1617109"/>
          </a:xfrm>
        </p:spPr>
        <p:txBody>
          <a:bodyPr/>
          <a:lstStyle>
            <a:lvl1pPr>
              <a:spcBef>
                <a:spcPts val="1050"/>
              </a:spcBef>
              <a:defRPr sz="2400"/>
            </a:lvl1pPr>
            <a:lvl2pPr>
              <a:spcBef>
                <a:spcPts val="600"/>
              </a:spcBef>
              <a:defRPr sz="2000"/>
            </a:lvl2pPr>
            <a:lvl3pPr>
              <a:defRPr sz="20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EEBE1E8-479A-2F4B-97FF-AB0E372472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01748" y="840767"/>
            <a:ext cx="11047227" cy="91011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455302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CCA9CF-BC0B-38DD-3541-AEFAFD555C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3304D2-0BEC-A9EA-3A59-64EFB99F8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343894-D9DE-F106-8D28-5BA4EFB41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84488C-9108-22E0-A81F-164E33AF5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6E81AC-16BF-FB9B-D15A-A46A1C71C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135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12CDDA-92D5-141B-3F7B-DE719AC6C7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B80D9F-FA94-0D91-662D-822659F10A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78CAA-8E35-C274-E008-799E40AA4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812E5-CF60-BDE2-C214-65ED23502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EDB57E-204F-7806-D1BA-13224F7EB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866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2B7F5-4E27-E2A1-88B7-52CB25E207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EF77D-9552-0C7D-3068-5F20622283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9162A0-07C4-40D1-E6D3-50BD43F40E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8D709D-776F-2256-A4B4-911EEDC87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1BB88D-7D5C-F40F-9FCB-B7CF6434D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D5B865-89F9-F4E5-7BE8-3C1EAB082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936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49F52-E4B5-0B07-1AC1-56239A6A7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35DB5C-547B-A749-0C3E-06210C3A5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358FD6-0DD6-F93A-6333-D54C91D7CE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6BDBE0-711D-7FD9-D5E4-28F5BAE089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8A19B2-8ACD-2A75-1633-8947F47FEA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D784E4-FA90-B831-84F9-DEAEB5E13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5DFEE0-E888-4696-625F-38A7807AD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E98ED8-3545-7831-7332-B48C51FA02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734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2CD507-4B43-EED7-ABE8-8B0AFB0B6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E0DF9F-FD1D-11B3-37F2-68BE836247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29FF5E1-C275-7639-5093-B2A211BF6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FC46A2-D483-5C55-7064-D784818B0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975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597F8E-2B4E-E217-96B3-F3101F086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117D2C-06B3-B368-0A2A-4B816C2E6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3BCF22-B587-777C-BF28-EBA13A7F4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46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3FE7CC-9598-CE96-7FFD-A312BDB24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422ADD-7B05-21BA-8FDE-678A077854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E29CA2-A4E2-4841-41F6-46054BEFF6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A4DCD6-5740-4833-73B0-86F28FACA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54E7E5-2886-F48E-816D-4A6D3F261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6FD7BF-8020-4480-C8B5-B9EFC030C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450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10F45-4CC9-4D99-1FFB-1DDD44CD2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E13B33-DCA3-673A-9E3B-E57B97061F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1C0175-F786-BB34-B0A0-EE2D09E82C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43C0A8-ECA0-FDCE-2D69-81BBEB2A5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C557D5-A922-DCE5-07C2-7387E84FC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309F19-464F-C20A-22CA-86112C84A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067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0AB23B-8E16-ECEC-FE32-7E3461923E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74967-4E56-211B-26DF-EE3938FE34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29338-E82C-3EDD-AC6D-75529080FA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13C4D4-0EFE-4DA1-8EA8-F584C4AA9782}" type="datetimeFigureOut">
              <a:rPr lang="en-US" smtClean="0"/>
              <a:t>1/3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3919F5-9515-46E8-90FA-05E64E8413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DA5E6D-4AC4-6DE5-A55F-4F755AC238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3E026F-7891-46F3-8C26-9AD7B63065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17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B2E2D69-6EB3-41AA-0A67-944498E453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0305" y="193595"/>
            <a:ext cx="5266795" cy="55886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5FB0448-CC80-BA36-F404-0157BA471845}"/>
              </a:ext>
            </a:extLst>
          </p:cNvPr>
          <p:cNvSpPr txBox="1"/>
          <p:nvPr/>
        </p:nvSpPr>
        <p:spPr>
          <a:xfrm>
            <a:off x="1845205" y="5874941"/>
            <a:ext cx="79972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1. </a:t>
            </a:r>
            <a:r>
              <a:rPr lang="en-US" dirty="0"/>
              <a:t>Flow diagram of study participants</a:t>
            </a:r>
          </a:p>
        </p:txBody>
      </p:sp>
    </p:spTree>
    <p:extLst>
      <p:ext uri="{BB962C8B-B14F-4D97-AF65-F5344CB8AC3E}">
        <p14:creationId xmlns:p14="http://schemas.microsoft.com/office/powerpoint/2010/main" val="1179654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73E9D33-32CE-76A8-ECCE-5D7B450DD9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3559" y="0"/>
            <a:ext cx="10328441" cy="678683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20BC62F-0086-39B5-94AC-80FDDC886CAC}"/>
              </a:ext>
            </a:extLst>
          </p:cNvPr>
          <p:cNvSpPr txBox="1"/>
          <p:nvPr/>
        </p:nvSpPr>
        <p:spPr>
          <a:xfrm>
            <a:off x="7643765" y="71163"/>
            <a:ext cx="2684675" cy="1328023"/>
          </a:xfrm>
          <a:prstGeom prst="round2Diag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/>
              <a:t>Dashboard provides a way to manage cases and invitation contact workflow.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5ACEC66-FFA9-BFCB-54DD-AD8279E1395A}"/>
              </a:ext>
            </a:extLst>
          </p:cNvPr>
          <p:cNvCxnSpPr>
            <a:cxnSpLocks/>
          </p:cNvCxnSpPr>
          <p:nvPr/>
        </p:nvCxnSpPr>
        <p:spPr>
          <a:xfrm>
            <a:off x="1477665" y="2322709"/>
            <a:ext cx="402672" cy="83889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0CA7402F-0F4E-D459-0E36-7D27D2FFEA38}"/>
              </a:ext>
            </a:extLst>
          </p:cNvPr>
          <p:cNvSpPr txBox="1"/>
          <p:nvPr/>
        </p:nvSpPr>
        <p:spPr>
          <a:xfrm>
            <a:off x="0" y="419448"/>
            <a:ext cx="1863559" cy="2208133"/>
          </a:xfrm>
          <a:prstGeom prst="round2Diag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r>
              <a:rPr lang="en-US"/>
              <a:t>Templates for email invitations.  </a:t>
            </a:r>
          </a:p>
          <a:p>
            <a:r>
              <a:rPr lang="en-US"/>
              <a:t>Sites need to customize the email subject and body.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7B701B8E-8671-1426-8E04-C6E119946C2A}"/>
              </a:ext>
            </a:extLst>
          </p:cNvPr>
          <p:cNvCxnSpPr>
            <a:cxnSpLocks/>
          </p:cNvCxnSpPr>
          <p:nvPr/>
        </p:nvCxnSpPr>
        <p:spPr>
          <a:xfrm flipH="1">
            <a:off x="8623883" y="1350679"/>
            <a:ext cx="178769" cy="58717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5139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9C8C17F-799B-CCAA-5789-B2793F3F3A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9573" y="0"/>
            <a:ext cx="10441144" cy="683717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20BC62F-0086-39B5-94AC-80FDDC886CAC}"/>
              </a:ext>
            </a:extLst>
          </p:cNvPr>
          <p:cNvSpPr txBox="1"/>
          <p:nvPr/>
        </p:nvSpPr>
        <p:spPr>
          <a:xfrm>
            <a:off x="3592584" y="0"/>
            <a:ext cx="5006832" cy="340519"/>
          </a:xfrm>
          <a:prstGeom prst="round2Diag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Continuation of dashboard from previous slide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5ACEC66-FFA9-BFCB-54DD-AD8279E1395A}"/>
              </a:ext>
            </a:extLst>
          </p:cNvPr>
          <p:cNvCxnSpPr>
            <a:cxnSpLocks/>
          </p:cNvCxnSpPr>
          <p:nvPr/>
        </p:nvCxnSpPr>
        <p:spPr>
          <a:xfrm>
            <a:off x="1587925" y="4487084"/>
            <a:ext cx="240875" cy="756035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0CA7402F-0F4E-D459-0E36-7D27D2FFEA38}"/>
              </a:ext>
            </a:extLst>
          </p:cNvPr>
          <p:cNvSpPr txBox="1"/>
          <p:nvPr/>
        </p:nvSpPr>
        <p:spPr>
          <a:xfrm>
            <a:off x="58252" y="3315460"/>
            <a:ext cx="1681321" cy="2188488"/>
          </a:xfrm>
          <a:prstGeom prst="round2Diag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2"/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/>
              <a:t>Report for updating the Coordinating Center REDCap project with site data. </a:t>
            </a:r>
          </a:p>
        </p:txBody>
      </p:sp>
    </p:spTree>
    <p:extLst>
      <p:ext uri="{BB962C8B-B14F-4D97-AF65-F5344CB8AC3E}">
        <p14:creationId xmlns:p14="http://schemas.microsoft.com/office/powerpoint/2010/main" val="6550866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7793186C-9ED6-1B2E-9035-6D85C79D5C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Syncing Site and Coordinating Center REDCap Projects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3B0724-13E0-1D95-53E8-328ACD2ECD8D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/>
              <a:t>Sites were advised to add records to their project only by exporting records from the Coordinating Center project and then importing those records into their local project.</a:t>
            </a:r>
          </a:p>
          <a:p>
            <a:pPr lvl="1"/>
            <a:r>
              <a:rPr lang="en-US"/>
              <a:t>This ensured that Record ID (auto-generated by REDCap) and </a:t>
            </a:r>
            <a:r>
              <a:rPr lang="en-US" err="1"/>
              <a:t>PARTICIPANT_ID</a:t>
            </a:r>
            <a:r>
              <a:rPr lang="en-US"/>
              <a:t> (unique ID used in the study portal) were synced across projects.</a:t>
            </a:r>
          </a:p>
          <a:p>
            <a:pPr lvl="1"/>
            <a:r>
              <a:rPr lang="en-US"/>
              <a:t>This initial export/import included temporary user credentials and web links.</a:t>
            </a:r>
          </a:p>
          <a:p>
            <a:pPr lvl="1"/>
            <a:r>
              <a:rPr lang="en-US"/>
              <a:t>The clip below shows the fields that were exported/imported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D29A4B6-71B1-486E-C4E3-5032ED99C2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3798154"/>
            <a:ext cx="11734800" cy="7188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99973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3DF792-D85A-CB07-4170-4D402C8FB9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E0D1579C-7F82-8B2B-2032-57E55B882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Syncing Site and Coordinating Center REDCap Projects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A69FDBE-F86A-3500-F08D-617DC59C4D7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/>
              <a:t>Sites were encouraged to export/import records prior to sending out follow-up invitations to patients. </a:t>
            </a:r>
          </a:p>
          <a:p>
            <a:pPr lvl="1"/>
            <a:r>
              <a:rPr lang="en-US"/>
              <a:t>The purpose was for sites to leverage data collected by the Coordinating Center (CC) to exclude patients who already enrolled, or who the CC logged as declined or deceased.</a:t>
            </a:r>
          </a:p>
          <a:p>
            <a:pPr lvl="1"/>
            <a:r>
              <a:rPr lang="en-US"/>
              <a:t>This logic was built into site reports as part of the template.</a:t>
            </a:r>
          </a:p>
          <a:p>
            <a:pPr lvl="1"/>
            <a:r>
              <a:rPr lang="en-US"/>
              <a:t>Below is an example of the kinds of fields included in this exportable report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A746F3A-136D-DE5E-EA5B-140241B7DE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40" y="3657600"/>
            <a:ext cx="12059521" cy="2647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05271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9ABAE0-0304-2FAC-6783-02CC2300F9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F8DE26-BDC1-C795-F9AE-9CC2273D10E6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701749" y="1965963"/>
            <a:ext cx="11047228" cy="1617109"/>
          </a:xfrm>
        </p:spPr>
        <p:txBody>
          <a:bodyPr>
            <a:normAutofit fontScale="92500" lnSpcReduction="20000"/>
          </a:bodyPr>
          <a:lstStyle/>
          <a:p>
            <a:r>
              <a:rPr lang="en-US"/>
              <a:t>Sites were also asked to provide updates after new activity was logged in their REDCap projects.</a:t>
            </a:r>
          </a:p>
          <a:p>
            <a:pPr lvl="1"/>
            <a:r>
              <a:rPr lang="en-US"/>
              <a:t>This included making initial or follow up recruitment contacts, patient declines and withdrawals, and change in patient vital status.</a:t>
            </a:r>
          </a:p>
          <a:p>
            <a:pPr lvl="1"/>
            <a:r>
              <a:rPr lang="en-US"/>
              <a:t>The report used for providing this info to the CC also included eligibility assessment information.</a:t>
            </a:r>
          </a:p>
          <a:p>
            <a:pPr lvl="1"/>
            <a:r>
              <a:rPr lang="en-US"/>
              <a:t>Fields included are listed below.</a:t>
            </a: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06205FE1-D6AA-3669-ECB0-DAE67BEDD0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01748" y="840767"/>
            <a:ext cx="11047227" cy="910114"/>
          </a:xfrm>
        </p:spPr>
        <p:txBody>
          <a:bodyPr>
            <a:normAutofit fontScale="90000"/>
          </a:bodyPr>
          <a:lstStyle/>
          <a:p>
            <a:r>
              <a:rPr lang="en-US"/>
              <a:t>Syncing Site and Coordinating Center REDCap Projects</a:t>
            </a:r>
          </a:p>
        </p:txBody>
      </p:sp>
      <p:sp>
        <p:nvSpPr>
          <p:cNvPr id="2" name="Text Placeholder 4">
            <a:extLst>
              <a:ext uri="{FF2B5EF4-FFF2-40B4-BE49-F238E27FC236}">
                <a16:creationId xmlns:a16="http://schemas.microsoft.com/office/drawing/2014/main" id="{50BD1004-0208-75A8-C942-1C04574ACFF1}"/>
              </a:ext>
            </a:extLst>
          </p:cNvPr>
          <p:cNvSpPr txBox="1">
            <a:spLocks/>
          </p:cNvSpPr>
          <p:nvPr/>
        </p:nvSpPr>
        <p:spPr>
          <a:xfrm>
            <a:off x="1711397" y="3582988"/>
            <a:ext cx="11375953" cy="2574071"/>
          </a:xfrm>
          <a:prstGeom prst="rect">
            <a:avLst/>
          </a:prstGeom>
        </p:spPr>
        <p:txBody>
          <a:bodyPr vert="horz" lIns="91440" tIns="45720" rIns="91440" bIns="45720" numCol="2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5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Record ID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PARTICIPANT_ID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oes the patient meet eligibility criteria?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ate eligibility assessed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How was eligibility for this patient assessed?</a:t>
            </a:r>
          </a:p>
          <a:p>
            <a:pPr lvl="1"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Using the computable phenotype - ran against the EMR</a:t>
            </a:r>
          </a:p>
          <a:p>
            <a:pPr lvl="1"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Using the computable phenotype - ran against the TUMOR table / cancer registry</a:t>
            </a:r>
          </a:p>
          <a:p>
            <a:pPr lvl="1"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Manual review of the patient's medical record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ate determined to be ineligible  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Invitation contact date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Invitation contact type 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Re-attempt invitation?  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ate invitation was re-attempted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ate patient declined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Reason(s) for decline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ate of subject withdrawal 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Reason(s) for withdrawal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Vital status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Date of death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Final invitation sent flag</a:t>
            </a:r>
          </a:p>
          <a:p>
            <a:pPr>
              <a:lnSpc>
                <a:spcPct val="120000"/>
              </a:lnSpc>
              <a:spcBef>
                <a:spcPts val="0"/>
              </a:spcBef>
            </a:pPr>
            <a:r>
              <a:rPr lang="en-US" sz="1400"/>
              <a:t>Notes</a:t>
            </a:r>
          </a:p>
        </p:txBody>
      </p:sp>
    </p:spTree>
    <p:extLst>
      <p:ext uri="{BB962C8B-B14F-4D97-AF65-F5344CB8AC3E}">
        <p14:creationId xmlns:p14="http://schemas.microsoft.com/office/powerpoint/2010/main" val="4033951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54DEA68EF37124D9522B82B9375B65C" ma:contentTypeVersion="20" ma:contentTypeDescription="Create a new document." ma:contentTypeScope="" ma:versionID="b475e1bebacf1cb2da6c2757891b34fe">
  <xsd:schema xmlns:xsd="http://www.w3.org/2001/XMLSchema" xmlns:xs="http://www.w3.org/2001/XMLSchema" xmlns:p="http://schemas.microsoft.com/office/2006/metadata/properties" xmlns:ns2="32fc8665-eb4d-4452-9ef0-a1d74fa9e4bd" xmlns:ns3="bde1d33b-c224-433a-893e-b7d4f561c18d" targetNamespace="http://schemas.microsoft.com/office/2006/metadata/properties" ma:root="true" ma:fieldsID="21f574eb1840986d15739df96b1476f8" ns2:_="" ns3:_="">
    <xsd:import namespace="32fc8665-eb4d-4452-9ef0-a1d74fa9e4bd"/>
    <xsd:import namespace="bde1d33b-c224-433a-893e-b7d4f561c18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fc8665-eb4d-4452-9ef0-a1d74fa9e4b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8af9f51b-2984-4022-8acc-3c23a99e8b1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20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1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3" nillable="true" ma:displayName="Location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de1d33b-c224-433a-893e-b7d4f561c18d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8ccf6eba-041e-4ea1-9a69-3ebde67bb6a2}" ma:internalName="TaxCatchAll" ma:showField="CatchAllData" ma:web="bde1d33b-c224-433a-893e-b7d4f561c18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2fc8665-eb4d-4452-9ef0-a1d74fa9e4bd">
      <Terms xmlns="http://schemas.microsoft.com/office/infopath/2007/PartnerControls"/>
    </lcf76f155ced4ddcb4097134ff3c332f>
    <TaxCatchAll xmlns="bde1d33b-c224-433a-893e-b7d4f561c18d" xsi:nil="true"/>
  </documentManagement>
</p:properties>
</file>

<file path=customXml/itemProps1.xml><?xml version="1.0" encoding="utf-8"?>
<ds:datastoreItem xmlns:ds="http://schemas.openxmlformats.org/officeDocument/2006/customXml" ds:itemID="{BDDFC123-B724-41B7-A80E-79EE95DAFD9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6C07E64-4C1B-45CD-A79A-A4591C779D91}">
  <ds:schemaRefs>
    <ds:schemaRef ds:uri="32fc8665-eb4d-4452-9ef0-a1d74fa9e4bd"/>
    <ds:schemaRef ds:uri="bde1d33b-c224-433a-893e-b7d4f561c18d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60BCA816-B169-4DC6-842B-D098A9572527}">
  <ds:schemaRefs>
    <ds:schemaRef ds:uri="32fc8665-eb4d-4452-9ef0-a1d74fa9e4bd"/>
    <ds:schemaRef ds:uri="bde1d33b-c224-433a-893e-b7d4f561c18d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6</Words>
  <Application>Microsoft Office PowerPoint</Application>
  <PresentationFormat>Widescreen</PresentationFormat>
  <Paragraphs>44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Syncing Site and Coordinating Center REDCap Projects</vt:lpstr>
      <vt:lpstr>Syncing Site and Coordinating Center REDCap Projects</vt:lpstr>
      <vt:lpstr>Syncing Site and Coordinating Center REDCap Project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ryzlak, Brian M</dc:creator>
  <cp:lastModifiedBy>O'Rorke, Michael A</cp:lastModifiedBy>
  <cp:revision>1</cp:revision>
  <dcterms:created xsi:type="dcterms:W3CDTF">2025-05-08T13:59:15Z</dcterms:created>
  <dcterms:modified xsi:type="dcterms:W3CDTF">2026-01-30T22:08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54DEA68EF37124D9522B82B9375B65C</vt:lpwstr>
  </property>
  <property fmtid="{D5CDD505-2E9C-101B-9397-08002B2CF9AE}" pid="3" name="MediaServiceImageTags">
    <vt:lpwstr/>
  </property>
</Properties>
</file>